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106" d="100"/>
          <a:sy n="106" d="100"/>
        </p:scale>
        <p:origin x="-1680" y="-90"/>
      </p:cViewPr>
      <p:guideLst>
        <p:guide orient="horz" pos="120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82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692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8204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58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413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60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841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921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6685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4333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0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47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14489" b="5418"/>
          <a:stretch/>
        </p:blipFill>
        <p:spPr bwMode="auto">
          <a:xfrm>
            <a:off x="0" y="1397670"/>
            <a:ext cx="9144000" cy="4119562"/>
          </a:xfrm>
          <a:prstGeom prst="rect">
            <a:avLst/>
          </a:prstGeom>
          <a:noFill/>
          <a:ln w="9525">
            <a:solidFill>
              <a:schemeClr val="tx1">
                <a:lumMod val="50000"/>
                <a:lumOff val="50000"/>
              </a:schemeClr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1933342" y="2743104"/>
            <a:ext cx="108000" cy="5040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3052265" y="3429000"/>
            <a:ext cx="108000" cy="5040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6128730" y="4111312"/>
            <a:ext cx="108000" cy="5040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직사각형 9"/>
          <p:cNvSpPr/>
          <p:nvPr/>
        </p:nvSpPr>
        <p:spPr>
          <a:xfrm>
            <a:off x="1421719" y="4803380"/>
            <a:ext cx="108000" cy="5040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직사각형 10"/>
          <p:cNvSpPr/>
          <p:nvPr/>
        </p:nvSpPr>
        <p:spPr>
          <a:xfrm>
            <a:off x="1844242" y="4797152"/>
            <a:ext cx="108000" cy="5040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/>
          <p:cNvSpPr/>
          <p:nvPr/>
        </p:nvSpPr>
        <p:spPr>
          <a:xfrm>
            <a:off x="4672744" y="4114952"/>
            <a:ext cx="108000" cy="504000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rgbClr val="0070C0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95536" y="692696"/>
            <a:ext cx="4914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Transgelin2 (query) vs. Calponin1 (subject)</a:t>
            </a:r>
            <a:endParaRPr lang="ko-KR" altLang="en-US" b="1" dirty="0"/>
          </a:p>
        </p:txBody>
      </p:sp>
      <p:sp>
        <p:nvSpPr>
          <p:cNvPr id="2" name="직사각형 1"/>
          <p:cNvSpPr/>
          <p:nvPr/>
        </p:nvSpPr>
        <p:spPr>
          <a:xfrm>
            <a:off x="3750634" y="4077072"/>
            <a:ext cx="1872000" cy="576064"/>
          </a:xfrm>
          <a:prstGeom prst="rect">
            <a:avLst/>
          </a:pr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TextBox 13"/>
          <p:cNvSpPr txBox="1"/>
          <p:nvPr/>
        </p:nvSpPr>
        <p:spPr>
          <a:xfrm>
            <a:off x="4273681" y="4653136"/>
            <a:ext cx="623889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solidFill>
                  <a:srgbClr val="0070C0"/>
                </a:solidFill>
              </a:rPr>
              <a:t>ABS</a:t>
            </a:r>
            <a:endParaRPr lang="ko-KR" altLang="en-US" b="1" dirty="0">
              <a:solidFill>
                <a:srgbClr val="0070C0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120092" y="24879"/>
            <a:ext cx="988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tabLst>
                <a:tab pos="896938" algn="l"/>
              </a:tabLst>
            </a:pPr>
            <a:r>
              <a:rPr lang="en-US" altLang="ko-KR" sz="1400" dirty="0" smtClean="0"/>
              <a:t>Figure S7.</a:t>
            </a:r>
            <a:endParaRPr lang="ko-KR" altLang="en-US" sz="1400" dirty="0"/>
          </a:p>
        </p:txBody>
      </p:sp>
      <p:sp>
        <p:nvSpPr>
          <p:cNvPr id="4" name="자유형 3"/>
          <p:cNvSpPr/>
          <p:nvPr/>
        </p:nvSpPr>
        <p:spPr>
          <a:xfrm>
            <a:off x="5652120" y="4078540"/>
            <a:ext cx="760242" cy="576000"/>
          </a:xfrm>
          <a:custGeom>
            <a:avLst/>
            <a:gdLst>
              <a:gd name="connsiteX0" fmla="*/ 658026 w 666572"/>
              <a:gd name="connsiteY0" fmla="*/ 0 h 598206"/>
              <a:gd name="connsiteX1" fmla="*/ 0 w 666572"/>
              <a:gd name="connsiteY1" fmla="*/ 0 h 598206"/>
              <a:gd name="connsiteX2" fmla="*/ 0 w 666572"/>
              <a:gd name="connsiteY2" fmla="*/ 598206 h 598206"/>
              <a:gd name="connsiteX3" fmla="*/ 666572 w 666572"/>
              <a:gd name="connsiteY3" fmla="*/ 598206 h 5982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66572" h="598206">
                <a:moveTo>
                  <a:pt x="658026" y="0"/>
                </a:moveTo>
                <a:lnTo>
                  <a:pt x="0" y="0"/>
                </a:lnTo>
                <a:lnTo>
                  <a:pt x="0" y="598206"/>
                </a:lnTo>
                <a:lnTo>
                  <a:pt x="666572" y="598206"/>
                </a:lnTo>
              </a:path>
            </a:pathLst>
          </a:cu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자유형 15"/>
          <p:cNvSpPr/>
          <p:nvPr/>
        </p:nvSpPr>
        <p:spPr>
          <a:xfrm flipH="1">
            <a:off x="1244392" y="4763244"/>
            <a:ext cx="1404000" cy="576000"/>
          </a:xfrm>
          <a:custGeom>
            <a:avLst/>
            <a:gdLst>
              <a:gd name="connsiteX0" fmla="*/ 658026 w 666572"/>
              <a:gd name="connsiteY0" fmla="*/ 0 h 598206"/>
              <a:gd name="connsiteX1" fmla="*/ 0 w 666572"/>
              <a:gd name="connsiteY1" fmla="*/ 0 h 598206"/>
              <a:gd name="connsiteX2" fmla="*/ 0 w 666572"/>
              <a:gd name="connsiteY2" fmla="*/ 598206 h 598206"/>
              <a:gd name="connsiteX3" fmla="*/ 666572 w 666572"/>
              <a:gd name="connsiteY3" fmla="*/ 598206 h 5982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66572" h="598206">
                <a:moveTo>
                  <a:pt x="658026" y="0"/>
                </a:moveTo>
                <a:lnTo>
                  <a:pt x="0" y="0"/>
                </a:lnTo>
                <a:lnTo>
                  <a:pt x="0" y="598206"/>
                </a:lnTo>
                <a:lnTo>
                  <a:pt x="666572" y="598206"/>
                </a:lnTo>
              </a:path>
            </a:pathLst>
          </a:cu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/>
          <p:cNvSpPr txBox="1"/>
          <p:nvPr/>
        </p:nvSpPr>
        <p:spPr>
          <a:xfrm>
            <a:off x="5820319" y="4653136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solidFill>
                  <a:srgbClr val="0070C0"/>
                </a:solidFill>
              </a:rPr>
              <a:t>CNR</a:t>
            </a:r>
            <a:endParaRPr lang="ko-KR" altLang="en-US" b="1" dirty="0">
              <a:solidFill>
                <a:srgbClr val="0070C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8812" y="5589240"/>
            <a:ext cx="6312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*ABS denotes actin binding site and CNR denotes calponin repeat domain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784235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04</TotalTime>
  <Words>28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9</cp:revision>
  <dcterms:created xsi:type="dcterms:W3CDTF">2014-03-20T17:14:01Z</dcterms:created>
  <dcterms:modified xsi:type="dcterms:W3CDTF">2015-01-25T07:06:32Z</dcterms:modified>
</cp:coreProperties>
</file>